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EF222D-A2E8-DCED-A8F8-8CCE195D69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712A73-F28B-41DD-1150-E98B7F4CEA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F7200E-CF9A-BAF6-3B75-91D0EA667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7576E6-11AB-E496-D8E7-08F0FEBABF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45F233-0B75-53F7-5A9C-F4859ECDD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431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99DB19-2CDD-7C57-2FB1-93FD83F13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C383EB-9AA4-87A7-063F-93F8ACE432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4D355C-E28D-B863-D7CA-CB78B3465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9128F4-243A-3878-5EF9-23A9F365B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6655DC-EB3B-8777-6283-822D23403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914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96E6D1-08D8-2555-4182-17CFD2F6DB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84454B-6681-7A1A-693E-D2896174C3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622B62-1CE1-CA3C-FA4D-B0AF182C6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EF5ED9-6D67-3871-B52D-9D1E03A4F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1FAA66-1CAC-E7AD-5BBC-E34216B81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327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D4141-CBB8-073C-CDB8-FCA8C5983C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00D1EE-3B61-22D0-5AD4-D9C8B2D051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B5193-8036-73E7-7AD9-D13EC6DE5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A553B6-FD4C-095D-CB62-B6EB1681C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B52D72-085D-C6F0-00D5-559E1998B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172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5ABB7-142B-A291-2EE6-81F8969ABB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1020F5-9336-AF03-F5C8-29EB97208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040B31-4DCA-39A4-F3F2-3601DFE1E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D15C93-826F-40ED-71E8-3A3D20F4FF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84AC88-8E06-E50D-AF6A-E3D9E66D5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23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E41F65-A6D1-C287-96AA-845486739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DBA1C4-B520-650A-9A0F-466DD04DE4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BD970B-F338-086C-4D2C-F84064B5EB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162C4A-0A87-2E7D-703B-7BF31892C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76B701-5A6E-2498-1CD9-60AE3653C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C72A3B-827E-ADC8-5062-00261FD8E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291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6EAFF5-53C3-1277-6297-8B32646E40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62A74C-EA7C-7219-D6D5-1BDE91CA3A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438486-4481-AFDC-A2A4-BF440782DC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46E7DC-F4DB-650C-3BD0-A0D1F1B4D8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F6A7128-0443-4E80-EA26-169C8DBDB1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754E00-1C61-F772-786A-99974FC6D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832C23-BA58-C6F7-51DE-1A22F5552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670945-BEE1-951B-4280-6D2180774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1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349204-AD76-324E-43EB-9515C01451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FF12D8-5AEE-A894-C17E-61FCB1CAB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C0211C-2F36-C1D2-9D37-711FDA686A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E92B2B-12CD-1EDA-9509-B1A714930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132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881E57C-2B75-FA25-3DEF-84D98E729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113EC61-BF4B-EADE-78AC-FAED28639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31CF1B-CB91-2DDD-152F-BE4CA3AB2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435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2A1B9A-E6B4-05F2-C51D-70D9B13F4C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DFBEF1-8649-C86F-7B32-18A0B7C07F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DB9F65-8C2F-8361-EBD5-D8DF9EA2F9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B252D8-8C8B-DE97-C7CB-F14638363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C9C243-1219-8B71-2047-4C9C34FF9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F5A0FC-1B42-80A2-719E-D168BA2B1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470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CD4621-283B-B722-4BC1-3E3741B7E7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1A4DE6-3EDC-CE11-E3C3-ABEDCC0EE2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7ADBF7-27BF-696C-2AA4-9809EFBDFD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8667E8-412A-5F7E-E08F-57FF29818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F65334-9DF3-23AA-81F1-D3F890BD8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FA5861-E7C2-5DF7-9D49-752EE137A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297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CD8D93-A262-26B7-5375-D30B61D22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8EDF67-81A1-53E8-0481-A344E0B31B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F55AE6-A779-40BA-B400-10F34F9A06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EA7D9-C042-A749-9EF1-4A0DA6492CE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73AA19-8DC7-2DF9-82B5-28CD5BE3D6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19190C-2A1F-3869-3FBB-15881064C4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E3E4E-EE07-C64B-80D0-15FF91C65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277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993F8EBA-61DC-5696-9FC2-BE6F6FEFF64F}"/>
              </a:ext>
            </a:extLst>
          </p:cNvPr>
          <p:cNvSpPr txBox="1"/>
          <p:nvPr/>
        </p:nvSpPr>
        <p:spPr>
          <a:xfrm>
            <a:off x="4370576" y="107274"/>
            <a:ext cx="41197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Histones vs Calcium Channel Blocker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0F969D5-A51E-409A-5A90-06A8D065921F}"/>
              </a:ext>
            </a:extLst>
          </p:cNvPr>
          <p:cNvGrpSpPr/>
          <p:nvPr/>
        </p:nvGrpSpPr>
        <p:grpSpPr>
          <a:xfrm>
            <a:off x="1529294" y="856042"/>
            <a:ext cx="8013371" cy="433578"/>
            <a:chOff x="1550827" y="632045"/>
            <a:chExt cx="8013371" cy="433578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FB924EB-48DA-153B-93E6-885502669943}"/>
                </a:ext>
              </a:extLst>
            </p:cNvPr>
            <p:cNvSpPr txBox="1"/>
            <p:nvPr/>
          </p:nvSpPr>
          <p:spPr>
            <a:xfrm>
              <a:off x="1550827" y="757846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CB0DBC5-E460-A616-833C-FB45212C980A}"/>
                </a:ext>
              </a:extLst>
            </p:cNvPr>
            <p:cNvSpPr txBox="1"/>
            <p:nvPr/>
          </p:nvSpPr>
          <p:spPr>
            <a:xfrm>
              <a:off x="5145790" y="632045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B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44193F-D827-38E9-DF41-AC7CB5012A4D}"/>
                </a:ext>
              </a:extLst>
            </p:cNvPr>
            <p:cNvSpPr txBox="1"/>
            <p:nvPr/>
          </p:nvSpPr>
          <p:spPr>
            <a:xfrm>
              <a:off x="9151906" y="738686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88AA1238-0119-7B0D-0FC4-068584BA13CD}"/>
              </a:ext>
            </a:extLst>
          </p:cNvPr>
          <p:cNvGrpSpPr/>
          <p:nvPr/>
        </p:nvGrpSpPr>
        <p:grpSpPr>
          <a:xfrm>
            <a:off x="1639902" y="3763388"/>
            <a:ext cx="8317509" cy="416084"/>
            <a:chOff x="1848984" y="6042778"/>
            <a:chExt cx="8317509" cy="416084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1792E80-30DB-F64C-BA23-3488D1BF4D5E}"/>
                </a:ext>
              </a:extLst>
            </p:cNvPr>
            <p:cNvSpPr txBox="1"/>
            <p:nvPr/>
          </p:nvSpPr>
          <p:spPr>
            <a:xfrm>
              <a:off x="1848984" y="6042778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20D0292-5948-C23C-B371-0BEBD6A3DBF0}"/>
                </a:ext>
              </a:extLst>
            </p:cNvPr>
            <p:cNvSpPr txBox="1"/>
            <p:nvPr/>
          </p:nvSpPr>
          <p:spPr>
            <a:xfrm>
              <a:off x="5213161" y="6095948"/>
              <a:ext cx="7088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/H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760EF86-430B-FE9F-1DCF-656F62323FF1}"/>
                </a:ext>
              </a:extLst>
            </p:cNvPr>
            <p:cNvSpPr txBox="1"/>
            <p:nvPr/>
          </p:nvSpPr>
          <p:spPr>
            <a:xfrm>
              <a:off x="9036440" y="6151085"/>
              <a:ext cx="11300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MacroH2A1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055074C-C3A0-A242-27B6-BB76898B32AB}"/>
              </a:ext>
            </a:extLst>
          </p:cNvPr>
          <p:cNvSpPr txBox="1"/>
          <p:nvPr/>
        </p:nvSpPr>
        <p:spPr>
          <a:xfrm>
            <a:off x="1346589" y="3324169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844395C-F724-33B2-C6E7-69FF151D7DC5}"/>
              </a:ext>
            </a:extLst>
          </p:cNvPr>
          <p:cNvSpPr txBox="1"/>
          <p:nvPr/>
        </p:nvSpPr>
        <p:spPr>
          <a:xfrm>
            <a:off x="2126342" y="3316551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F5904C-989A-288B-21DE-94DBF72CFB53}"/>
              </a:ext>
            </a:extLst>
          </p:cNvPr>
          <p:cNvSpPr txBox="1"/>
          <p:nvPr/>
        </p:nvSpPr>
        <p:spPr>
          <a:xfrm>
            <a:off x="667824" y="3324169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EEA9FBD0-32B1-DBBF-3F88-69E17218775C}"/>
              </a:ext>
            </a:extLst>
          </p:cNvPr>
          <p:cNvSpPr/>
          <p:nvPr/>
        </p:nvSpPr>
        <p:spPr>
          <a:xfrm>
            <a:off x="2532438" y="1074416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263E7DD-570F-FFC6-1642-F83D63BACB71}"/>
              </a:ext>
            </a:extLst>
          </p:cNvPr>
          <p:cNvSpPr/>
          <p:nvPr/>
        </p:nvSpPr>
        <p:spPr>
          <a:xfrm>
            <a:off x="2532438" y="1210910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B047040-6216-5FBB-A273-B6C3DB46FEDA}"/>
              </a:ext>
            </a:extLst>
          </p:cNvPr>
          <p:cNvSpPr txBox="1"/>
          <p:nvPr/>
        </p:nvSpPr>
        <p:spPr>
          <a:xfrm>
            <a:off x="2633318" y="968806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D81DE32-C71E-DA56-183D-CF4E2D9083C0}"/>
              </a:ext>
            </a:extLst>
          </p:cNvPr>
          <p:cNvSpPr txBox="1"/>
          <p:nvPr/>
        </p:nvSpPr>
        <p:spPr>
          <a:xfrm>
            <a:off x="2633317" y="1125240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pic>
        <p:nvPicPr>
          <p:cNvPr id="24" name="Content Placeholder 5">
            <a:extLst>
              <a:ext uri="{FF2B5EF4-FFF2-40B4-BE49-F238E27FC236}">
                <a16:creationId xmlns:a16="http://schemas.microsoft.com/office/drawing/2014/main" id="{B3AD7773-2722-F512-558B-B588909706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4" r="21932" b="6482"/>
          <a:stretch/>
        </p:blipFill>
        <p:spPr>
          <a:xfrm>
            <a:off x="436595" y="1396024"/>
            <a:ext cx="2708299" cy="1972471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ADCB6523-9E83-78B3-1F31-B5A24FB4DBFF}"/>
              </a:ext>
            </a:extLst>
          </p:cNvPr>
          <p:cNvSpPr txBox="1"/>
          <p:nvPr/>
        </p:nvSpPr>
        <p:spPr>
          <a:xfrm>
            <a:off x="5015632" y="3368495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98A27FF-A589-3442-E5C9-9ACB2ED33516}"/>
              </a:ext>
            </a:extLst>
          </p:cNvPr>
          <p:cNvSpPr txBox="1"/>
          <p:nvPr/>
        </p:nvSpPr>
        <p:spPr>
          <a:xfrm>
            <a:off x="5697214" y="3350538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FD591B3-3BC7-8743-B9BC-4A641C10D6CF}"/>
              </a:ext>
            </a:extLst>
          </p:cNvPr>
          <p:cNvSpPr txBox="1"/>
          <p:nvPr/>
        </p:nvSpPr>
        <p:spPr>
          <a:xfrm>
            <a:off x="4238696" y="335815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37B7A3DF-0A13-B767-6259-09BF933A5391}"/>
              </a:ext>
            </a:extLst>
          </p:cNvPr>
          <p:cNvSpPr/>
          <p:nvPr/>
        </p:nvSpPr>
        <p:spPr>
          <a:xfrm>
            <a:off x="6133779" y="980078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93D42F7-83A6-61CC-4521-45B95A4B33FF}"/>
              </a:ext>
            </a:extLst>
          </p:cNvPr>
          <p:cNvSpPr/>
          <p:nvPr/>
        </p:nvSpPr>
        <p:spPr>
          <a:xfrm>
            <a:off x="6133779" y="111657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5B0BFB0-0A87-1630-A06E-9211C29498C9}"/>
              </a:ext>
            </a:extLst>
          </p:cNvPr>
          <p:cNvSpPr txBox="1"/>
          <p:nvPr/>
        </p:nvSpPr>
        <p:spPr>
          <a:xfrm>
            <a:off x="6234659" y="874468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39DA2F5-63A0-8FDA-69AD-018CB8302986}"/>
              </a:ext>
            </a:extLst>
          </p:cNvPr>
          <p:cNvSpPr txBox="1"/>
          <p:nvPr/>
        </p:nvSpPr>
        <p:spPr>
          <a:xfrm>
            <a:off x="6234658" y="1030902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pic>
        <p:nvPicPr>
          <p:cNvPr id="36" name="Content Placeholder 6">
            <a:extLst>
              <a:ext uri="{FF2B5EF4-FFF2-40B4-BE49-F238E27FC236}">
                <a16:creationId xmlns:a16="http://schemas.microsoft.com/office/drawing/2014/main" id="{AEA910C3-4553-B4A0-31A0-1172B0C00C7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7" r="21056" b="6580"/>
          <a:stretch/>
        </p:blipFill>
        <p:spPr>
          <a:xfrm>
            <a:off x="3826597" y="1231303"/>
            <a:ext cx="2941012" cy="2178708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0AE67B36-A6BB-C6B0-F4CD-3A27C7FBD5D6}"/>
              </a:ext>
            </a:extLst>
          </p:cNvPr>
          <p:cNvSpPr txBox="1"/>
          <p:nvPr/>
        </p:nvSpPr>
        <p:spPr>
          <a:xfrm>
            <a:off x="8977028" y="3335441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61BB9B4-28D5-A67B-BFF4-3722F6B84CED}"/>
              </a:ext>
            </a:extLst>
          </p:cNvPr>
          <p:cNvSpPr txBox="1"/>
          <p:nvPr/>
        </p:nvSpPr>
        <p:spPr>
          <a:xfrm>
            <a:off x="9710267" y="3316551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359DAC9-C529-6817-B961-5A524D8A119E}"/>
              </a:ext>
            </a:extLst>
          </p:cNvPr>
          <p:cNvSpPr txBox="1"/>
          <p:nvPr/>
        </p:nvSpPr>
        <p:spPr>
          <a:xfrm>
            <a:off x="8185636" y="333544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0B8D4BF3-3FCD-4AE7-54F5-538B2B3F86C8}"/>
              </a:ext>
            </a:extLst>
          </p:cNvPr>
          <p:cNvSpPr/>
          <p:nvPr/>
        </p:nvSpPr>
        <p:spPr>
          <a:xfrm>
            <a:off x="10050250" y="1085688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9051025C-2A02-6C10-E7BF-2066D81BDFF4}"/>
              </a:ext>
            </a:extLst>
          </p:cNvPr>
          <p:cNvSpPr/>
          <p:nvPr/>
        </p:nvSpPr>
        <p:spPr>
          <a:xfrm>
            <a:off x="10050250" y="122218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0F66EF7-20A3-DD1D-5C9C-75E0B177340F}"/>
              </a:ext>
            </a:extLst>
          </p:cNvPr>
          <p:cNvSpPr txBox="1"/>
          <p:nvPr/>
        </p:nvSpPr>
        <p:spPr>
          <a:xfrm>
            <a:off x="10151130" y="980078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01313A9-A3D5-ED4F-489C-F5B27845D1C0}"/>
              </a:ext>
            </a:extLst>
          </p:cNvPr>
          <p:cNvSpPr txBox="1"/>
          <p:nvPr/>
        </p:nvSpPr>
        <p:spPr>
          <a:xfrm>
            <a:off x="10151129" y="1136512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pic>
        <p:nvPicPr>
          <p:cNvPr id="45" name="Content Placeholder 6">
            <a:extLst>
              <a:ext uri="{FF2B5EF4-FFF2-40B4-BE49-F238E27FC236}">
                <a16:creationId xmlns:a16="http://schemas.microsoft.com/office/drawing/2014/main" id="{C0ED103E-1A42-2AB1-C566-51EBD225453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8" r="21688" b="6047"/>
          <a:stretch/>
        </p:blipFill>
        <p:spPr>
          <a:xfrm>
            <a:off x="7877611" y="1339641"/>
            <a:ext cx="2833942" cy="2059493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026E84D7-D8C1-294B-B96E-EC9BA59B975F}"/>
              </a:ext>
            </a:extLst>
          </p:cNvPr>
          <p:cNvSpPr txBox="1"/>
          <p:nvPr/>
        </p:nvSpPr>
        <p:spPr>
          <a:xfrm rot="16200000">
            <a:off x="123849" y="2354964"/>
            <a:ext cx="394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A</a:t>
            </a:r>
            <a:endParaRPr lang="en-US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84C9A3F-DC19-57D5-2AF4-AD21A295C3D3}"/>
              </a:ext>
            </a:extLst>
          </p:cNvPr>
          <p:cNvSpPr txBox="1"/>
          <p:nvPr/>
        </p:nvSpPr>
        <p:spPr>
          <a:xfrm rot="16200000">
            <a:off x="7598528" y="2336377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</a:t>
            </a:r>
            <a:endParaRPr lang="en-US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1DD1B5B-EA65-E029-A4CF-3BB9EA11A2EA}"/>
              </a:ext>
            </a:extLst>
          </p:cNvPr>
          <p:cNvSpPr txBox="1"/>
          <p:nvPr/>
        </p:nvSpPr>
        <p:spPr>
          <a:xfrm rot="16200000">
            <a:off x="3513050" y="2353919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B</a:t>
            </a:r>
            <a:endParaRPr lang="en-US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6CDB233-7425-C57B-4B7F-35DAA8646C40}"/>
              </a:ext>
            </a:extLst>
          </p:cNvPr>
          <p:cNvSpPr txBox="1"/>
          <p:nvPr/>
        </p:nvSpPr>
        <p:spPr>
          <a:xfrm>
            <a:off x="1558030" y="6321082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2FD0DEF-5631-B671-CC03-D08FE31D81DD}"/>
              </a:ext>
            </a:extLst>
          </p:cNvPr>
          <p:cNvSpPr txBox="1"/>
          <p:nvPr/>
        </p:nvSpPr>
        <p:spPr>
          <a:xfrm>
            <a:off x="2239612" y="6303125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776398D-8BE6-CB61-6AA7-7EDDF28073A6}"/>
              </a:ext>
            </a:extLst>
          </p:cNvPr>
          <p:cNvSpPr txBox="1"/>
          <p:nvPr/>
        </p:nvSpPr>
        <p:spPr>
          <a:xfrm>
            <a:off x="781094" y="6310743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B6619F08-2587-F57E-0048-242ED734CEBE}"/>
              </a:ext>
            </a:extLst>
          </p:cNvPr>
          <p:cNvSpPr/>
          <p:nvPr/>
        </p:nvSpPr>
        <p:spPr>
          <a:xfrm>
            <a:off x="2676177" y="3932665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91F22043-6478-DA7D-E8A1-BDB9D46F6BC7}"/>
              </a:ext>
            </a:extLst>
          </p:cNvPr>
          <p:cNvSpPr/>
          <p:nvPr/>
        </p:nvSpPr>
        <p:spPr>
          <a:xfrm>
            <a:off x="2676177" y="4069159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0D47FCF-5E26-4760-D35E-EA3E99E48565}"/>
              </a:ext>
            </a:extLst>
          </p:cNvPr>
          <p:cNvSpPr txBox="1"/>
          <p:nvPr/>
        </p:nvSpPr>
        <p:spPr>
          <a:xfrm>
            <a:off x="2777057" y="3827055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FA24A48-0E5B-669C-9101-76554FDC05B4}"/>
              </a:ext>
            </a:extLst>
          </p:cNvPr>
          <p:cNvSpPr txBox="1"/>
          <p:nvPr/>
        </p:nvSpPr>
        <p:spPr>
          <a:xfrm>
            <a:off x="2777056" y="3983489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E90DE92-A126-C513-D08E-0956CD8B859B}"/>
              </a:ext>
            </a:extLst>
          </p:cNvPr>
          <p:cNvSpPr txBox="1"/>
          <p:nvPr/>
        </p:nvSpPr>
        <p:spPr>
          <a:xfrm rot="16200000">
            <a:off x="203388" y="5348223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4</a:t>
            </a:r>
            <a:endParaRPr lang="en-US" dirty="0"/>
          </a:p>
        </p:txBody>
      </p:sp>
      <p:pic>
        <p:nvPicPr>
          <p:cNvPr id="58" name="Content Placeholder 6">
            <a:extLst>
              <a:ext uri="{FF2B5EF4-FFF2-40B4-BE49-F238E27FC236}">
                <a16:creationId xmlns:a16="http://schemas.microsoft.com/office/drawing/2014/main" id="{6FEBCDAE-DC3E-5BB8-E948-E7740364AA8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5" r="21930" b="6723"/>
          <a:stretch/>
        </p:blipFill>
        <p:spPr>
          <a:xfrm>
            <a:off x="490704" y="4192070"/>
            <a:ext cx="2708299" cy="2129012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D2A9809F-F415-E786-73C3-0ADA13B36AAF}"/>
              </a:ext>
            </a:extLst>
          </p:cNvPr>
          <p:cNvSpPr txBox="1"/>
          <p:nvPr/>
        </p:nvSpPr>
        <p:spPr>
          <a:xfrm>
            <a:off x="4985238" y="6328387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C32AB6B-6395-4291-757E-E6E729C3ADF6}"/>
              </a:ext>
            </a:extLst>
          </p:cNvPr>
          <p:cNvSpPr txBox="1"/>
          <p:nvPr/>
        </p:nvSpPr>
        <p:spPr>
          <a:xfrm>
            <a:off x="5666820" y="6310430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0160B64-6493-7461-CD11-5B5E76321B83}"/>
              </a:ext>
            </a:extLst>
          </p:cNvPr>
          <p:cNvSpPr txBox="1"/>
          <p:nvPr/>
        </p:nvSpPr>
        <p:spPr>
          <a:xfrm>
            <a:off x="4208302" y="631804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13A65EBC-BE0A-8D7E-5386-7C045BA1A96C}"/>
              </a:ext>
            </a:extLst>
          </p:cNvPr>
          <p:cNvSpPr/>
          <p:nvPr/>
        </p:nvSpPr>
        <p:spPr>
          <a:xfrm>
            <a:off x="6103385" y="3939970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BEC955D-27CB-4B29-EC1F-4C33FF710C7E}"/>
              </a:ext>
            </a:extLst>
          </p:cNvPr>
          <p:cNvSpPr/>
          <p:nvPr/>
        </p:nvSpPr>
        <p:spPr>
          <a:xfrm>
            <a:off x="6103385" y="4076464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FD13103-10BF-37BF-1D32-969D0CB747EB}"/>
              </a:ext>
            </a:extLst>
          </p:cNvPr>
          <p:cNvSpPr txBox="1"/>
          <p:nvPr/>
        </p:nvSpPr>
        <p:spPr>
          <a:xfrm>
            <a:off x="6204265" y="3834360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E6F91EC-7163-4097-95AC-EB72661CAC4E}"/>
              </a:ext>
            </a:extLst>
          </p:cNvPr>
          <p:cNvSpPr txBox="1"/>
          <p:nvPr/>
        </p:nvSpPr>
        <p:spPr>
          <a:xfrm>
            <a:off x="6204264" y="3990794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953EE87-E243-8E3C-7473-BEA57B7D83F9}"/>
              </a:ext>
            </a:extLst>
          </p:cNvPr>
          <p:cNvSpPr txBox="1"/>
          <p:nvPr/>
        </p:nvSpPr>
        <p:spPr>
          <a:xfrm rot="16200000">
            <a:off x="3544322" y="5282838"/>
            <a:ext cx="5084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/H4</a:t>
            </a:r>
            <a:endParaRPr lang="en-US" dirty="0"/>
          </a:p>
        </p:txBody>
      </p:sp>
      <p:pic>
        <p:nvPicPr>
          <p:cNvPr id="78" name="Content Placeholder 6">
            <a:extLst>
              <a:ext uri="{FF2B5EF4-FFF2-40B4-BE49-F238E27FC236}">
                <a16:creationId xmlns:a16="http://schemas.microsoft.com/office/drawing/2014/main" id="{41C2674A-BE07-F999-41F4-73A0F5688BC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7" r="21056" b="6580"/>
          <a:stretch/>
        </p:blipFill>
        <p:spPr>
          <a:xfrm>
            <a:off x="3826597" y="4162153"/>
            <a:ext cx="2941012" cy="2178708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9C072118-4A00-9DB8-19D3-5B5D32F89729}"/>
              </a:ext>
            </a:extLst>
          </p:cNvPr>
          <p:cNvSpPr txBox="1"/>
          <p:nvPr/>
        </p:nvSpPr>
        <p:spPr>
          <a:xfrm>
            <a:off x="8930008" y="6350638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2A7606C-1F03-EA13-9453-830D1A7971FC}"/>
              </a:ext>
            </a:extLst>
          </p:cNvPr>
          <p:cNvSpPr txBox="1"/>
          <p:nvPr/>
        </p:nvSpPr>
        <p:spPr>
          <a:xfrm>
            <a:off x="9611590" y="6332681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980FA82-162E-D117-201F-CC92A8C546CC}"/>
              </a:ext>
            </a:extLst>
          </p:cNvPr>
          <p:cNvSpPr txBox="1"/>
          <p:nvPr/>
        </p:nvSpPr>
        <p:spPr>
          <a:xfrm>
            <a:off x="8153072" y="6340299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6BC53BCD-16F2-A28F-333F-C721278D4949}"/>
              </a:ext>
            </a:extLst>
          </p:cNvPr>
          <p:cNvSpPr/>
          <p:nvPr/>
        </p:nvSpPr>
        <p:spPr>
          <a:xfrm>
            <a:off x="10048155" y="3962221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5CAEA6DA-8721-D604-33FC-0EE3E14B40BA}"/>
              </a:ext>
            </a:extLst>
          </p:cNvPr>
          <p:cNvSpPr/>
          <p:nvPr/>
        </p:nvSpPr>
        <p:spPr>
          <a:xfrm>
            <a:off x="10048155" y="4098715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1A0EC73-AE9A-4F52-D33C-7CD65104E490}"/>
              </a:ext>
            </a:extLst>
          </p:cNvPr>
          <p:cNvSpPr txBox="1"/>
          <p:nvPr/>
        </p:nvSpPr>
        <p:spPr>
          <a:xfrm>
            <a:off x="10149035" y="3856611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206A14C-D182-C447-F7A0-F464B7B59D66}"/>
              </a:ext>
            </a:extLst>
          </p:cNvPr>
          <p:cNvSpPr txBox="1"/>
          <p:nvPr/>
        </p:nvSpPr>
        <p:spPr>
          <a:xfrm>
            <a:off x="10149034" y="4013045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A57AE92-78DB-8066-B51F-1322DCEBDBB9}"/>
              </a:ext>
            </a:extLst>
          </p:cNvPr>
          <p:cNvSpPr txBox="1"/>
          <p:nvPr/>
        </p:nvSpPr>
        <p:spPr>
          <a:xfrm rot="16200000">
            <a:off x="7353351" y="5377779"/>
            <a:ext cx="7713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croH2A1</a:t>
            </a:r>
            <a:endParaRPr lang="en-US" dirty="0"/>
          </a:p>
        </p:txBody>
      </p:sp>
      <p:pic>
        <p:nvPicPr>
          <p:cNvPr id="88" name="Content Placeholder 6">
            <a:extLst>
              <a:ext uri="{FF2B5EF4-FFF2-40B4-BE49-F238E27FC236}">
                <a16:creationId xmlns:a16="http://schemas.microsoft.com/office/drawing/2014/main" id="{62D1035A-9D86-CDA2-11DC-C2287FEB6E6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4" r="21873" b="6580"/>
          <a:stretch/>
        </p:blipFill>
        <p:spPr>
          <a:xfrm>
            <a:off x="7875390" y="4198926"/>
            <a:ext cx="2833942" cy="2178707"/>
          </a:xfrm>
          <a:prstGeom prst="rect">
            <a:avLst/>
          </a:prstGeom>
        </p:spPr>
      </p:pic>
      <p:sp>
        <p:nvSpPr>
          <p:cNvPr id="89" name="TextBox 88">
            <a:extLst>
              <a:ext uri="{FF2B5EF4-FFF2-40B4-BE49-F238E27FC236}">
                <a16:creationId xmlns:a16="http://schemas.microsoft.com/office/drawing/2014/main" id="{25E85E53-89EE-F8C8-DB83-353AE60D101F}"/>
              </a:ext>
            </a:extLst>
          </p:cNvPr>
          <p:cNvSpPr txBox="1"/>
          <p:nvPr/>
        </p:nvSpPr>
        <p:spPr>
          <a:xfrm>
            <a:off x="2426394" y="858365"/>
            <a:ext cx="14590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Calcium Channel Blocker</a:t>
            </a:r>
            <a:endParaRPr lang="en-US" sz="900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BED4A908-8053-CCFE-D8FE-FFD6C58797FA}"/>
              </a:ext>
            </a:extLst>
          </p:cNvPr>
          <p:cNvSpPr txBox="1"/>
          <p:nvPr/>
        </p:nvSpPr>
        <p:spPr>
          <a:xfrm>
            <a:off x="9938763" y="845665"/>
            <a:ext cx="14590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Calcium Channel Blocker</a:t>
            </a:r>
            <a:endParaRPr lang="en-US" sz="9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EBD656C-069E-BDC6-F6FA-678072263621}"/>
              </a:ext>
            </a:extLst>
          </p:cNvPr>
          <p:cNvSpPr txBox="1"/>
          <p:nvPr/>
        </p:nvSpPr>
        <p:spPr>
          <a:xfrm>
            <a:off x="6024387" y="754212"/>
            <a:ext cx="14590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Calcium Channel Blocker</a:t>
            </a:r>
            <a:endParaRPr lang="en-US" sz="900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53179293-FC8C-CE75-1CCA-E7CB1D8353B0}"/>
              </a:ext>
            </a:extLst>
          </p:cNvPr>
          <p:cNvSpPr txBox="1"/>
          <p:nvPr/>
        </p:nvSpPr>
        <p:spPr>
          <a:xfrm>
            <a:off x="9938763" y="3720605"/>
            <a:ext cx="14590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Calcium Channel Blocker</a:t>
            </a:r>
            <a:endParaRPr lang="en-US" sz="9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9C0D7D3-7B99-F9A5-6627-9154B6BFD3D2}"/>
              </a:ext>
            </a:extLst>
          </p:cNvPr>
          <p:cNvSpPr txBox="1"/>
          <p:nvPr/>
        </p:nvSpPr>
        <p:spPr>
          <a:xfrm>
            <a:off x="5993993" y="3718944"/>
            <a:ext cx="14590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Calcium Channel Blocker</a:t>
            </a:r>
            <a:endParaRPr lang="en-US" sz="9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37771CA2-D6A0-0EF6-3DE2-4065E043C953}"/>
              </a:ext>
            </a:extLst>
          </p:cNvPr>
          <p:cNvSpPr txBox="1"/>
          <p:nvPr/>
        </p:nvSpPr>
        <p:spPr>
          <a:xfrm>
            <a:off x="2575550" y="3682924"/>
            <a:ext cx="14590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Calcium Channel Blocker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412460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</Words>
  <Application>Microsoft Macintosh PowerPoint</Application>
  <PresentationFormat>Widescreen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lio Vinciguera</dc:creator>
  <cp:lastModifiedBy>Manlio Vinciguera</cp:lastModifiedBy>
  <cp:revision>1</cp:revision>
  <dcterms:created xsi:type="dcterms:W3CDTF">2025-11-02T17:49:30Z</dcterms:created>
  <dcterms:modified xsi:type="dcterms:W3CDTF">2025-11-02T17:49:44Z</dcterms:modified>
</cp:coreProperties>
</file>